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480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-360"/>
            <a:ext cx="294480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39480" y="1240920"/>
            <a:ext cx="2514600" cy="3351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79720"/>
            <a:ext cx="5435640" cy="390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8E4908-46EE-4BCE-B147-3358B8A90B39}" type="slidenum">
              <a:rPr b="0" lang="fr-FR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139840" y="1241280"/>
            <a:ext cx="2514600" cy="335124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78960" y="4779720"/>
            <a:ext cx="5435640" cy="39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Espace réservé du numéro de diapositive 3"/>
          <p:cNvSpPr/>
          <p:nvPr/>
        </p:nvSpPr>
        <p:spPr>
          <a:xfrm>
            <a:off x="3848040" y="9433080"/>
            <a:ext cx="2944800" cy="49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21CAE0-5610-4EE6-83ED-4EE3965AB8D6}" type="slidenum">
              <a:rPr b="0" lang="fr-FR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A03818-31D6-4509-8915-C8BB2BD49A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0A9B2-5C1F-4BBC-B1B4-48DDC02ACA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55192-72D7-4420-B251-93ABF7DA9A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16E4E-E378-48E0-BD2F-9D7A8A292F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DD521-0FAB-4546-964D-D849EF2238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44981-609F-42CE-85FB-64441566AC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6B0B99-6EB9-41A5-8863-BC597D1E68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45FD5-8317-4176-B01B-85D0EA6361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34DD3-FDF0-425B-B04A-3ED765F1FD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550B2-A17F-4642-A33C-7C41D101F0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F6A86-EE04-492B-B243-92345C62A9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0416D-D690-45A1-81C2-4051EC2D6B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AA06B4-2FA8-4E58-A564-082EDFAEFC72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1"/>
          <p:cNvGrpSpPr/>
          <p:nvPr/>
        </p:nvGrpSpPr>
        <p:grpSpPr>
          <a:xfrm>
            <a:off x="1341360" y="1281960"/>
            <a:ext cx="3683160" cy="2982240"/>
            <a:chOff x="1341360" y="1281960"/>
            <a:chExt cx="3683160" cy="2982240"/>
          </a:xfrm>
        </p:grpSpPr>
        <p:grpSp>
          <p:nvGrpSpPr>
            <p:cNvPr id="49" name="组合 10"/>
            <p:cNvGrpSpPr/>
            <p:nvPr/>
          </p:nvGrpSpPr>
          <p:grpSpPr>
            <a:xfrm>
              <a:off x="1341360" y="1281960"/>
              <a:ext cx="3683160" cy="2353680"/>
              <a:chOff x="1341360" y="1281960"/>
              <a:chExt cx="3683160" cy="2353680"/>
            </a:xfrm>
          </p:grpSpPr>
          <p:sp>
            <p:nvSpPr>
              <p:cNvPr id="50" name="ZoneTexte 20"/>
              <p:cNvSpPr/>
              <p:nvPr/>
            </p:nvSpPr>
            <p:spPr>
              <a:xfrm>
                <a:off x="1341360" y="312516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4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ZoneTexte 20"/>
              <p:cNvSpPr/>
              <p:nvPr/>
            </p:nvSpPr>
            <p:spPr>
              <a:xfrm>
                <a:off x="1341360" y="299124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6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ZoneTexte 20"/>
              <p:cNvSpPr/>
              <p:nvPr/>
            </p:nvSpPr>
            <p:spPr>
              <a:xfrm>
                <a:off x="1341360" y="3058200"/>
                <a:ext cx="618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500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b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ZoneTexte 12"/>
              <p:cNvSpPr/>
              <p:nvPr/>
            </p:nvSpPr>
            <p:spPr>
              <a:xfrm rot="19360800">
                <a:off x="2459880" y="1511640"/>
                <a:ext cx="642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29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ZoneTexte 12"/>
              <p:cNvSpPr/>
              <p:nvPr/>
            </p:nvSpPr>
            <p:spPr>
              <a:xfrm rot="19360800">
                <a:off x="2686320" y="1526040"/>
                <a:ext cx="585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37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ZoneTexte 12"/>
              <p:cNvSpPr/>
              <p:nvPr/>
            </p:nvSpPr>
            <p:spPr>
              <a:xfrm rot="19360800">
                <a:off x="3375360" y="1539000"/>
                <a:ext cx="585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92A&gt;G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ZoneTexte 12"/>
              <p:cNvSpPr/>
              <p:nvPr/>
            </p:nvSpPr>
            <p:spPr>
              <a:xfrm rot="19360800">
                <a:off x="3531600" y="1514160"/>
                <a:ext cx="745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Empty vecto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ZoneTexte 12"/>
              <p:cNvSpPr/>
              <p:nvPr/>
            </p:nvSpPr>
            <p:spPr>
              <a:xfrm rot="19360800">
                <a:off x="1936800" y="1485000"/>
                <a:ext cx="74736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ZoneTexte 12"/>
              <p:cNvSpPr/>
              <p:nvPr/>
            </p:nvSpPr>
            <p:spPr>
              <a:xfrm rot="19360800">
                <a:off x="2180880" y="1512720"/>
                <a:ext cx="661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Wild-typ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ZoneTexte 12"/>
              <p:cNvSpPr/>
              <p:nvPr/>
            </p:nvSpPr>
            <p:spPr>
              <a:xfrm rot="19360800">
                <a:off x="3141360" y="1505520"/>
                <a:ext cx="6426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81A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ZoneTexte 12"/>
              <p:cNvSpPr/>
              <p:nvPr/>
            </p:nvSpPr>
            <p:spPr>
              <a:xfrm rot="19360800">
                <a:off x="2904840" y="1522800"/>
                <a:ext cx="5857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c.64G&gt;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1" name="图片 2" descr="门前面&#10;&#10;中度可信度描述已自动生成"/>
              <p:cNvPicPr/>
              <p:nvPr/>
            </p:nvPicPr>
            <p:blipFill>
              <a:blip r:embed="rId1"/>
              <a:srcRect l="12407" t="13123" r="6079" b="27822"/>
              <a:stretch/>
            </p:blipFill>
            <p:spPr>
              <a:xfrm>
                <a:off x="1754640" y="1843200"/>
                <a:ext cx="3269880" cy="1792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ZoneTexte 12"/>
              <p:cNvSpPr/>
              <p:nvPr/>
            </p:nvSpPr>
            <p:spPr>
              <a:xfrm rot="19360800">
                <a:off x="3820680" y="1472400"/>
                <a:ext cx="747360" cy="35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DNA marke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cxnSp>
            <p:nvCxnSpPr>
              <p:cNvPr id="63" name="Connecteur droit avec flèche 49"/>
              <p:cNvCxnSpPr/>
              <p:nvPr/>
            </p:nvCxnSpPr>
            <p:spPr>
              <a:xfrm flipH="1">
                <a:off x="3618720" y="313236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4" name="Connecteur droit avec flèche 49"/>
              <p:cNvCxnSpPr/>
              <p:nvPr/>
            </p:nvCxnSpPr>
            <p:spPr>
              <a:xfrm flipH="1">
                <a:off x="3388680" y="312444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5" name="Connecteur droit avec flèche 49"/>
              <p:cNvCxnSpPr/>
              <p:nvPr/>
            </p:nvCxnSpPr>
            <p:spPr>
              <a:xfrm flipH="1">
                <a:off x="3160080" y="3124440"/>
                <a:ext cx="45000" cy="6408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6" name="Connecteur droit avec flèche 49"/>
              <p:cNvCxnSpPr/>
              <p:nvPr/>
            </p:nvCxnSpPr>
            <p:spPr>
              <a:xfrm flipH="1">
                <a:off x="2944080" y="312444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7" name="Connecteur droit avec flèche 49"/>
              <p:cNvCxnSpPr/>
              <p:nvPr/>
            </p:nvCxnSpPr>
            <p:spPr>
              <a:xfrm flipH="1">
                <a:off x="2696400" y="312444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8" name="Connecteur droit avec flèche 49"/>
              <p:cNvCxnSpPr/>
              <p:nvPr/>
            </p:nvCxnSpPr>
            <p:spPr>
              <a:xfrm flipH="1">
                <a:off x="2493000" y="3132360"/>
                <a:ext cx="45000" cy="65520"/>
              </a:xfrm>
              <a:prstGeom prst="straightConnector1">
                <a:avLst/>
              </a:prstGeom>
              <a:ln cap="sq" w="12600">
                <a:solidFill>
                  <a:srgbClr val="000000"/>
                </a:solidFill>
                <a:miter/>
                <a:tailEnd len="sm" type="triangle" w="sm"/>
              </a:ln>
            </p:spPr>
          </p:cxnSp>
        </p:grpSp>
        <p:sp>
          <p:nvSpPr>
            <p:cNvPr id="69" name="ZoneTexte 92"/>
            <p:cNvSpPr/>
            <p:nvPr/>
          </p:nvSpPr>
          <p:spPr>
            <a:xfrm>
              <a:off x="2000880" y="4017960"/>
              <a:ext cx="2817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Figure S2.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ull-length gel image for Figure 10.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09T13:46:12Z</dcterms:created>
  <dc:creator>recherche20</dc:creator>
  <dc:description/>
  <dc:language>en-US</dc:language>
  <cp:lastModifiedBy>user</cp:lastModifiedBy>
  <cp:lastPrinted>2020-11-24T10:26:10Z</cp:lastPrinted>
  <dcterms:modified xsi:type="dcterms:W3CDTF">2024-02-09T09:40:40Z</dcterms:modified>
  <cp:revision>649</cp:revision>
  <dc:subject/>
  <dc:title>Diapositive 1</dc:title>
</cp:coreProperties>
</file>